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4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2519C5-207D-F353-5507-B032298ECC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D0BFBE5-D40B-75D5-C08D-23C9E6ED19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F6801B7-C18A-B366-A8F4-3AE8977DC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9DDCC33-7245-4723-C4DF-B36DF4EF9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2FD4367-C440-EF9C-C476-6FAB0D085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41361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BD4AD4-3CAD-8ECD-D0BD-9522BD14C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6C04271-8A9C-45AB-AE8D-629EA62998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4A77FD8-49C1-AEE7-0BB2-D894A129E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0EBEB58-C1C4-29A9-6D52-DAB18E4DE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0F7CC31-9096-1D72-E3EB-7633631CD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12861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4C0437D-2F0C-1A5E-717B-F6CCF4F46B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03433C2-5657-0140-A14C-3C1FC78CEF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16BFE58-2485-3684-9AC0-3AAEE7DE3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E681A18-89D7-3C64-5973-0E599AED3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9FF2446-97B4-2A7B-3F36-F94A4B586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45349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6611320-6E31-F953-B53A-81345A9C0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DB5728D-FF89-6223-D8F8-16AA51A27B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DC7D23-DDB4-530F-4CB1-963203EF3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758165E-2C0B-182B-AEEC-66E66B4A2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BE05420-4C89-737B-06E0-E728B3304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77354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B49B73-E640-685F-26C3-7A96349073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229EF5F-FDCF-4B89-A558-6EEE843DCE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4BE3EE7-1ECE-F310-F523-D83E0E624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B7BC956-3393-5C0B-B1BF-8905616B8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04A1286-5707-7E2B-0005-04767809B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4255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59CD43-7FD0-243C-E4CA-29BEFF27A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B60CE96-59A1-3118-EFE2-7D0A6D5E5B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1996A6E-71E5-2252-D029-372D4C797C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6B9CF57-B9E7-E5A3-D8BE-E14FDD5D1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B27A88F-F5AA-4A67-7F5B-F13C99651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F38911B-85F8-1DE2-BCE8-A95312B70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96832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42145A-14A4-0D18-52C5-B53CF8F571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CF9027B-7681-7DFD-47FC-E14B387326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03FEC03-F954-35C4-A745-F470AD6A86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1735A20-0D4F-6F80-EC1C-1E4B7DFC1B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0465B48-8755-8E7D-51BA-BB216DECAC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76D2ECDC-2CA1-0A8D-10E0-CD93405EC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AFEC575-0662-CE30-A2F0-DB9F28A11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3C372A5-959A-285E-F5CC-A2E025C22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26194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B6AD6BD-C4E5-33DD-A6C1-7FEBCF844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52B9C71-E4A2-FACD-4B69-E94B0D070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A677788-78C2-E041-294E-F5DB8F23C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E1B8B17-0429-3CAD-EF1F-31719D904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49417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3357B40-219C-247D-5CF7-D55CACBF5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F566580-02C0-9894-47D8-F596231D6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D5412C7-9C0C-08C5-3A2B-4FDE663E1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26889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656E65-523B-59DA-0C7C-8DCF1907B7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5CD899F-FE86-F24C-5B8F-20E23A64AB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B8DC759-4E80-B072-5174-B9FEBBD41A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BE4357E-8274-46A2-35FB-B362A74E3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98048CF-62EB-59F2-6320-8A5F29B03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B1BB7DC-BDB7-8FCA-3946-60DE8443C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34164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E40D32-6F87-504D-B123-7F48AEABB0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8659A4C-293B-EFC7-BCEC-AD2947FA72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72348F3-C76E-50C8-C8A7-AC38B7B16B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C45825E-9E5A-96FF-116B-530F14374D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9179916-70A3-F6AE-75DE-BE3BCCA57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766C881-022E-E4C6-53DB-E03BA977F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33132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86A4E06-CF7F-D1D9-1C12-0E9E98D9E6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CDBBFB6-0DBC-01DE-2B82-1C235C84A3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77AA0D4-D818-B29A-D5A8-753D7138FA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B902A-8239-4716-9042-15308ECB8D50}" type="datetimeFigureOut">
              <a:rPr lang="es-MX" smtClean="0"/>
              <a:t>13/11/2023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0C06A28-7994-E3EE-B320-6C11CD3E74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62F99B3-585B-A875-249A-07B006E823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3221A-D4AE-4EA6-9F71-AEA2C9DBDDA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65555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27143534-420A-1AA4-F443-F56CE26B8DF3}"/>
              </a:ext>
            </a:extLst>
          </p:cNvPr>
          <p:cNvSpPr txBox="1"/>
          <p:nvPr/>
        </p:nvSpPr>
        <p:spPr>
          <a:xfrm>
            <a:off x="-92387" y="1243383"/>
            <a:ext cx="1737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/>
              <a:t>LC3B (15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B1C96EFD-68B7-F2F3-AF46-C130858263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983" y="97000"/>
            <a:ext cx="2938527" cy="1542422"/>
          </a:xfrm>
          <a:prstGeom prst="rect">
            <a:avLst/>
          </a:prstGeom>
        </p:spPr>
      </p:pic>
      <p:grpSp>
        <p:nvGrpSpPr>
          <p:cNvPr id="6" name="Grupo 5">
            <a:extLst>
              <a:ext uri="{FF2B5EF4-FFF2-40B4-BE49-F238E27FC236}">
                <a16:creationId xmlns:a16="http://schemas.microsoft.com/office/drawing/2014/main" id="{992EAD23-F825-DB41-AB72-6F90F1A62E9B}"/>
              </a:ext>
            </a:extLst>
          </p:cNvPr>
          <p:cNvGrpSpPr/>
          <p:nvPr/>
        </p:nvGrpSpPr>
        <p:grpSpPr>
          <a:xfrm>
            <a:off x="2038866" y="1539723"/>
            <a:ext cx="2880644" cy="870910"/>
            <a:chOff x="1459743" y="2457859"/>
            <a:chExt cx="2880644" cy="870910"/>
          </a:xfrm>
        </p:grpSpPr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50616050-32DA-3729-D23D-A2837C58B0B5}"/>
                </a:ext>
              </a:extLst>
            </p:cNvPr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134EC3B5-2537-F069-05DB-611F004AD2DA}"/>
                </a:ext>
              </a:extLst>
            </p:cNvPr>
            <p:cNvSpPr txBox="1"/>
            <p:nvPr/>
          </p:nvSpPr>
          <p:spPr>
            <a:xfrm rot="5400000">
              <a:off x="2536529" y="2330874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DD173D51-7752-811F-1168-AFD8F9A13A90}"/>
                </a:ext>
              </a:extLst>
            </p:cNvPr>
            <p:cNvSpPr txBox="1"/>
            <p:nvPr/>
          </p:nvSpPr>
          <p:spPr>
            <a:xfrm rot="5400000">
              <a:off x="3405543" y="239392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 ZnO NPs</a:t>
              </a:r>
            </a:p>
          </p:txBody>
        </p:sp>
      </p:grpSp>
      <p:grpSp>
        <p:nvGrpSpPr>
          <p:cNvPr id="10" name="Grupo 9">
            <a:extLst>
              <a:ext uri="{FF2B5EF4-FFF2-40B4-BE49-F238E27FC236}">
                <a16:creationId xmlns:a16="http://schemas.microsoft.com/office/drawing/2014/main" id="{A9F58E4C-4C7A-8306-037B-3D8F00CB5036}"/>
              </a:ext>
            </a:extLst>
          </p:cNvPr>
          <p:cNvGrpSpPr/>
          <p:nvPr/>
        </p:nvGrpSpPr>
        <p:grpSpPr>
          <a:xfrm>
            <a:off x="1545872" y="184403"/>
            <a:ext cx="435111" cy="1355320"/>
            <a:chOff x="1117683" y="905016"/>
            <a:chExt cx="435111" cy="1355320"/>
          </a:xfrm>
        </p:grpSpPr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CDBBBFFF-C9CE-C6C4-4CE7-DEB7CE467AE5}"/>
                </a:ext>
              </a:extLst>
            </p:cNvPr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60935096-8DF5-E4AB-AE5C-F8A68D5FA26D}"/>
                </a:ext>
              </a:extLst>
            </p:cNvPr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C9F67C95-9500-763E-19E4-24151B3DC4CF}"/>
                </a:ext>
              </a:extLst>
            </p:cNvPr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15E41B84-010C-721B-C975-56630B454622}"/>
                </a:ext>
              </a:extLst>
            </p:cNvPr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85E0FB9D-68C3-798D-6CBA-9CFEE2145A9B}"/>
                </a:ext>
              </a:extLst>
            </p:cNvPr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sp>
        <p:nvSpPr>
          <p:cNvPr id="16" name="CuadroTexto 15">
            <a:extLst>
              <a:ext uri="{FF2B5EF4-FFF2-40B4-BE49-F238E27FC236}">
                <a16:creationId xmlns:a16="http://schemas.microsoft.com/office/drawing/2014/main" id="{49B533DB-CDCF-264F-C1E1-72103550A733}"/>
              </a:ext>
            </a:extLst>
          </p:cNvPr>
          <p:cNvSpPr txBox="1"/>
          <p:nvPr/>
        </p:nvSpPr>
        <p:spPr>
          <a:xfrm>
            <a:off x="5215779" y="425191"/>
            <a:ext cx="1737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/>
              <a:t>Beclin-1 (52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6D6A807C-41BE-2BCB-7BFB-3279F46557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lum bright="20000" contrast="20000"/>
          </a:blip>
          <a:srcRect l="8367"/>
          <a:stretch/>
        </p:blipFill>
        <p:spPr>
          <a:xfrm>
            <a:off x="7355694" y="133649"/>
            <a:ext cx="2922417" cy="1505773"/>
          </a:xfrm>
          <a:prstGeom prst="rect">
            <a:avLst/>
          </a:prstGeom>
        </p:spPr>
      </p:pic>
      <p:grpSp>
        <p:nvGrpSpPr>
          <p:cNvPr id="18" name="Grupo 17">
            <a:extLst>
              <a:ext uri="{FF2B5EF4-FFF2-40B4-BE49-F238E27FC236}">
                <a16:creationId xmlns:a16="http://schemas.microsoft.com/office/drawing/2014/main" id="{B370C7C4-D521-0E38-C630-4A38340035F4}"/>
              </a:ext>
            </a:extLst>
          </p:cNvPr>
          <p:cNvGrpSpPr/>
          <p:nvPr/>
        </p:nvGrpSpPr>
        <p:grpSpPr>
          <a:xfrm>
            <a:off x="6976222" y="218400"/>
            <a:ext cx="435111" cy="1355320"/>
            <a:chOff x="1117683" y="905016"/>
            <a:chExt cx="435111" cy="1355320"/>
          </a:xfrm>
        </p:grpSpPr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44FD29B9-7920-19DD-DFAA-99594121B838}"/>
                </a:ext>
              </a:extLst>
            </p:cNvPr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0AF35D7E-4799-B9F9-9FE0-2C690D83C472}"/>
                </a:ext>
              </a:extLst>
            </p:cNvPr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4311E7AE-DC47-B903-29A2-584696B52CDF}"/>
                </a:ext>
              </a:extLst>
            </p:cNvPr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7D62EAAC-EA7F-B613-AA84-32BFFCA77A72}"/>
                </a:ext>
              </a:extLst>
            </p:cNvPr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17404B48-2218-1B1B-13B0-6E8AF5F0A910}"/>
                </a:ext>
              </a:extLst>
            </p:cNvPr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grpSp>
        <p:nvGrpSpPr>
          <p:cNvPr id="24" name="Grupo 23">
            <a:extLst>
              <a:ext uri="{FF2B5EF4-FFF2-40B4-BE49-F238E27FC236}">
                <a16:creationId xmlns:a16="http://schemas.microsoft.com/office/drawing/2014/main" id="{CC0BB04E-FD49-F9DF-F09E-E17D9532CF68}"/>
              </a:ext>
            </a:extLst>
          </p:cNvPr>
          <p:cNvGrpSpPr/>
          <p:nvPr/>
        </p:nvGrpSpPr>
        <p:grpSpPr>
          <a:xfrm>
            <a:off x="7355694" y="1500922"/>
            <a:ext cx="2918352" cy="870910"/>
            <a:chOff x="1459743" y="2457859"/>
            <a:chExt cx="2918352" cy="870910"/>
          </a:xfrm>
        </p:grpSpPr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7E8B710F-6AC3-6769-FE35-ED280F8D8D54}"/>
                </a:ext>
              </a:extLst>
            </p:cNvPr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A6F7434-9618-7233-C4D6-A3ACBE6ED198}"/>
                </a:ext>
              </a:extLst>
            </p:cNvPr>
            <p:cNvSpPr txBox="1"/>
            <p:nvPr/>
          </p:nvSpPr>
          <p:spPr>
            <a:xfrm rot="5400000">
              <a:off x="2536529" y="2330874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B69A8254-D031-AD00-8185-349EA98A6EFE}"/>
                </a:ext>
              </a:extLst>
            </p:cNvPr>
            <p:cNvSpPr txBox="1"/>
            <p:nvPr/>
          </p:nvSpPr>
          <p:spPr>
            <a:xfrm rot="5400000">
              <a:off x="3443251" y="239392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 ZnO NPs ZnO NPs</a:t>
              </a:r>
            </a:p>
          </p:txBody>
        </p:sp>
      </p:grpSp>
      <p:cxnSp>
        <p:nvCxnSpPr>
          <p:cNvPr id="28" name="Conector recto de flecha 27">
            <a:extLst>
              <a:ext uri="{FF2B5EF4-FFF2-40B4-BE49-F238E27FC236}">
                <a16:creationId xmlns:a16="http://schemas.microsoft.com/office/drawing/2014/main" id="{DE0D23D2-2AF2-3473-C32D-5677A8EAC521}"/>
              </a:ext>
            </a:extLst>
          </p:cNvPr>
          <p:cNvCxnSpPr/>
          <p:nvPr/>
        </p:nvCxnSpPr>
        <p:spPr>
          <a:xfrm>
            <a:off x="6761069" y="582056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7610C980-A04E-A298-3C1F-83C9255A202A}"/>
              </a:ext>
            </a:extLst>
          </p:cNvPr>
          <p:cNvCxnSpPr/>
          <p:nvPr/>
        </p:nvCxnSpPr>
        <p:spPr>
          <a:xfrm>
            <a:off x="1360586" y="1398920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Grupo 29">
            <a:extLst>
              <a:ext uri="{FF2B5EF4-FFF2-40B4-BE49-F238E27FC236}">
                <a16:creationId xmlns:a16="http://schemas.microsoft.com/office/drawing/2014/main" id="{8DD58B45-D271-D273-0F9B-691CDC0FB435}"/>
              </a:ext>
            </a:extLst>
          </p:cNvPr>
          <p:cNvGrpSpPr/>
          <p:nvPr/>
        </p:nvGrpSpPr>
        <p:grpSpPr>
          <a:xfrm>
            <a:off x="7431502" y="4338610"/>
            <a:ext cx="2842544" cy="870910"/>
            <a:chOff x="1459743" y="2457859"/>
            <a:chExt cx="2842544" cy="870910"/>
          </a:xfrm>
        </p:grpSpPr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4B477450-4CAB-BF23-BF11-61BD60D5AD14}"/>
                </a:ext>
              </a:extLst>
            </p:cNvPr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B516A9D1-933D-47C2-90C7-CF815D935A45}"/>
                </a:ext>
              </a:extLst>
            </p:cNvPr>
            <p:cNvSpPr txBox="1"/>
            <p:nvPr/>
          </p:nvSpPr>
          <p:spPr>
            <a:xfrm rot="5400000">
              <a:off x="2488904" y="2330874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C3D7E423-3B20-ADF4-C993-44694E99F3CD}"/>
                </a:ext>
              </a:extLst>
            </p:cNvPr>
            <p:cNvSpPr txBox="1"/>
            <p:nvPr/>
          </p:nvSpPr>
          <p:spPr>
            <a:xfrm rot="5400000">
              <a:off x="3367443" y="239392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 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</p:txBody>
        </p:sp>
      </p:grpSp>
      <p:grpSp>
        <p:nvGrpSpPr>
          <p:cNvPr id="34" name="Grupo 33">
            <a:extLst>
              <a:ext uri="{FF2B5EF4-FFF2-40B4-BE49-F238E27FC236}">
                <a16:creationId xmlns:a16="http://schemas.microsoft.com/office/drawing/2014/main" id="{8DA4AC98-37B7-5A1E-53E5-D4ED60AF185A}"/>
              </a:ext>
            </a:extLst>
          </p:cNvPr>
          <p:cNvGrpSpPr/>
          <p:nvPr/>
        </p:nvGrpSpPr>
        <p:grpSpPr>
          <a:xfrm>
            <a:off x="7146810" y="2915122"/>
            <a:ext cx="435111" cy="1355320"/>
            <a:chOff x="1117683" y="905016"/>
            <a:chExt cx="435111" cy="1355320"/>
          </a:xfrm>
        </p:grpSpPr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54DD0D7E-042B-00C1-51ED-9574762413FE}"/>
                </a:ext>
              </a:extLst>
            </p:cNvPr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077A6053-9B3F-0A19-C174-E2788DC97E88}"/>
                </a:ext>
              </a:extLst>
            </p:cNvPr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ED84195A-9DCF-D464-0765-18C50650AAB9}"/>
                </a:ext>
              </a:extLst>
            </p:cNvPr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EB2C3131-8685-15A7-7535-E19DF468CCC5}"/>
                </a:ext>
              </a:extLst>
            </p:cNvPr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456C1A3A-8100-EC3B-701F-E2C6CF4434E4}"/>
                </a:ext>
              </a:extLst>
            </p:cNvPr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sp>
        <p:nvSpPr>
          <p:cNvPr id="40" name="CuadroTexto 39">
            <a:extLst>
              <a:ext uri="{FF2B5EF4-FFF2-40B4-BE49-F238E27FC236}">
                <a16:creationId xmlns:a16="http://schemas.microsoft.com/office/drawing/2014/main" id="{D790E0E6-1ABB-DECB-5387-147420A7321F}"/>
              </a:ext>
            </a:extLst>
          </p:cNvPr>
          <p:cNvSpPr txBox="1"/>
          <p:nvPr/>
        </p:nvSpPr>
        <p:spPr>
          <a:xfrm>
            <a:off x="5395295" y="3572134"/>
            <a:ext cx="1737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/>
              <a:t>GAPDH (36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41" name="Imagen 40">
            <a:extLst>
              <a:ext uri="{FF2B5EF4-FFF2-40B4-BE49-F238E27FC236}">
                <a16:creationId xmlns:a16="http://schemas.microsoft.com/office/drawing/2014/main" id="{CB5C1420-FC48-FD85-183A-04BB9EC3EAA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1088"/>
          <a:stretch/>
        </p:blipFill>
        <p:spPr>
          <a:xfrm>
            <a:off x="7521848" y="2779929"/>
            <a:ext cx="2699953" cy="1535643"/>
          </a:xfrm>
          <a:prstGeom prst="rect">
            <a:avLst/>
          </a:prstGeom>
        </p:spPr>
      </p:pic>
      <p:sp>
        <p:nvSpPr>
          <p:cNvPr id="42" name="CuadroTexto 41">
            <a:extLst>
              <a:ext uri="{FF2B5EF4-FFF2-40B4-BE49-F238E27FC236}">
                <a16:creationId xmlns:a16="http://schemas.microsoft.com/office/drawing/2014/main" id="{C24CAA51-AD39-20B8-64E7-CBA164DF9C15}"/>
              </a:ext>
            </a:extLst>
          </p:cNvPr>
          <p:cNvSpPr txBox="1"/>
          <p:nvPr/>
        </p:nvSpPr>
        <p:spPr>
          <a:xfrm>
            <a:off x="20558" y="4137273"/>
            <a:ext cx="14449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400" b="1" dirty="0"/>
              <a:t>Cox-IV (15 </a:t>
            </a:r>
            <a:r>
              <a:rPr lang="es-MX" sz="1400" b="1" dirty="0" err="1"/>
              <a:t>KDa</a:t>
            </a:r>
            <a:r>
              <a:rPr lang="es-MX" sz="1400" b="1" dirty="0"/>
              <a:t>)</a:t>
            </a:r>
          </a:p>
        </p:txBody>
      </p:sp>
      <p:pic>
        <p:nvPicPr>
          <p:cNvPr id="43" name="Imagen 42">
            <a:extLst>
              <a:ext uri="{FF2B5EF4-FFF2-40B4-BE49-F238E27FC236}">
                <a16:creationId xmlns:a16="http://schemas.microsoft.com/office/drawing/2014/main" id="{7FB529E0-2086-1BD0-9C0A-268FC9620F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1987319" y="2757113"/>
            <a:ext cx="2934476" cy="1750400"/>
          </a:xfrm>
          <a:prstGeom prst="rect">
            <a:avLst/>
          </a:prstGeom>
        </p:spPr>
      </p:pic>
      <p:grpSp>
        <p:nvGrpSpPr>
          <p:cNvPr id="44" name="Grupo 43">
            <a:extLst>
              <a:ext uri="{FF2B5EF4-FFF2-40B4-BE49-F238E27FC236}">
                <a16:creationId xmlns:a16="http://schemas.microsoft.com/office/drawing/2014/main" id="{FFA5E7B4-D598-C5E9-801A-D240649FBAF9}"/>
              </a:ext>
            </a:extLst>
          </p:cNvPr>
          <p:cNvGrpSpPr/>
          <p:nvPr/>
        </p:nvGrpSpPr>
        <p:grpSpPr>
          <a:xfrm>
            <a:off x="1631400" y="3108541"/>
            <a:ext cx="435111" cy="1355320"/>
            <a:chOff x="1117683" y="905016"/>
            <a:chExt cx="435111" cy="1355320"/>
          </a:xfrm>
        </p:grpSpPr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82E9FAB2-3E8D-6632-0943-1201422751CB}"/>
                </a:ext>
              </a:extLst>
            </p:cNvPr>
            <p:cNvSpPr txBox="1"/>
            <p:nvPr/>
          </p:nvSpPr>
          <p:spPr>
            <a:xfrm>
              <a:off x="1120423" y="1983337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15 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35EFDD3A-6179-E069-0A1A-621830694E59}"/>
                </a:ext>
              </a:extLst>
            </p:cNvPr>
            <p:cNvSpPr txBox="1"/>
            <p:nvPr/>
          </p:nvSpPr>
          <p:spPr>
            <a:xfrm>
              <a:off x="1131482" y="1690919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25 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DD8382A4-C2B8-2449-1B17-4810DA19FF6E}"/>
                </a:ext>
              </a:extLst>
            </p:cNvPr>
            <p:cNvSpPr txBox="1"/>
            <p:nvPr/>
          </p:nvSpPr>
          <p:spPr>
            <a:xfrm>
              <a:off x="1120422" y="1477885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37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4E41A6E7-DE0B-F655-7054-E212AA5BA57B}"/>
                </a:ext>
              </a:extLst>
            </p:cNvPr>
            <p:cNvSpPr txBox="1"/>
            <p:nvPr/>
          </p:nvSpPr>
          <p:spPr>
            <a:xfrm>
              <a:off x="1117683" y="1161194"/>
              <a:ext cx="340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50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62ACA479-D6F4-1308-DAC7-0CDB8C1685FA}"/>
                </a:ext>
              </a:extLst>
            </p:cNvPr>
            <p:cNvSpPr txBox="1"/>
            <p:nvPr/>
          </p:nvSpPr>
          <p:spPr>
            <a:xfrm>
              <a:off x="1123056" y="905016"/>
              <a:ext cx="4297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1200" dirty="0"/>
                <a:t>75</a:t>
              </a:r>
            </a:p>
          </p:txBody>
        </p:sp>
      </p:grpSp>
      <p:grpSp>
        <p:nvGrpSpPr>
          <p:cNvPr id="50" name="Grupo 49">
            <a:extLst>
              <a:ext uri="{FF2B5EF4-FFF2-40B4-BE49-F238E27FC236}">
                <a16:creationId xmlns:a16="http://schemas.microsoft.com/office/drawing/2014/main" id="{E4C708DA-91BB-3AD6-6812-034998D3B254}"/>
              </a:ext>
            </a:extLst>
          </p:cNvPr>
          <p:cNvGrpSpPr/>
          <p:nvPr/>
        </p:nvGrpSpPr>
        <p:grpSpPr>
          <a:xfrm>
            <a:off x="2041151" y="4401661"/>
            <a:ext cx="2880644" cy="870910"/>
            <a:chOff x="1459743" y="2457859"/>
            <a:chExt cx="2880644" cy="870910"/>
          </a:xfrm>
        </p:grpSpPr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D3981EE4-88E3-292A-236D-83888D914B17}"/>
                </a:ext>
              </a:extLst>
            </p:cNvPr>
            <p:cNvSpPr txBox="1"/>
            <p:nvPr/>
          </p:nvSpPr>
          <p:spPr>
            <a:xfrm rot="5400000">
              <a:off x="1586728" y="2372581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Control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13DFF7E3-80CB-E06F-2017-D992757BE08D}"/>
                </a:ext>
              </a:extLst>
            </p:cNvPr>
            <p:cNvSpPr txBox="1"/>
            <p:nvPr/>
          </p:nvSpPr>
          <p:spPr>
            <a:xfrm rot="5400000">
              <a:off x="2536529" y="2330874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E 171</a:t>
              </a:r>
            </a:p>
          </p:txBody>
        </p:sp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FEDFA592-D52A-A2A9-93AB-7007C92820A1}"/>
                </a:ext>
              </a:extLst>
            </p:cNvPr>
            <p:cNvSpPr txBox="1"/>
            <p:nvPr/>
          </p:nvSpPr>
          <p:spPr>
            <a:xfrm rot="5400000">
              <a:off x="3405543" y="2393925"/>
              <a:ext cx="807859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  <a:p>
              <a:pPr algn="ctr">
                <a:lnSpc>
                  <a:spcPct val="150000"/>
                </a:lnSpc>
              </a:pPr>
              <a:r>
                <a:rPr lang="es-MX" sz="1400" dirty="0"/>
                <a:t>ZnO NPs</a:t>
              </a:r>
            </a:p>
          </p:txBody>
        </p:sp>
      </p:grpSp>
      <p:cxnSp>
        <p:nvCxnSpPr>
          <p:cNvPr id="54" name="Conector recto de flecha 53">
            <a:extLst>
              <a:ext uri="{FF2B5EF4-FFF2-40B4-BE49-F238E27FC236}">
                <a16:creationId xmlns:a16="http://schemas.microsoft.com/office/drawing/2014/main" id="{59E8D12C-2D61-68DD-24F7-1BC479A0432F}"/>
              </a:ext>
            </a:extLst>
          </p:cNvPr>
          <p:cNvCxnSpPr/>
          <p:nvPr/>
        </p:nvCxnSpPr>
        <p:spPr>
          <a:xfrm>
            <a:off x="1434408" y="4314834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de flecha 54">
            <a:extLst>
              <a:ext uri="{FF2B5EF4-FFF2-40B4-BE49-F238E27FC236}">
                <a16:creationId xmlns:a16="http://schemas.microsoft.com/office/drawing/2014/main" id="{D5922C55-1F89-52BE-31F0-28FC7DA74520}"/>
              </a:ext>
            </a:extLst>
          </p:cNvPr>
          <p:cNvCxnSpPr/>
          <p:nvPr/>
        </p:nvCxnSpPr>
        <p:spPr>
          <a:xfrm>
            <a:off x="6931657" y="3737601"/>
            <a:ext cx="215153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ángulo 55">
            <a:extLst>
              <a:ext uri="{FF2B5EF4-FFF2-40B4-BE49-F238E27FC236}">
                <a16:creationId xmlns:a16="http://schemas.microsoft.com/office/drawing/2014/main" id="{6D81D3C4-73CD-E3C8-87D7-39A0475F5A8F}"/>
              </a:ext>
            </a:extLst>
          </p:cNvPr>
          <p:cNvSpPr/>
          <p:nvPr/>
        </p:nvSpPr>
        <p:spPr>
          <a:xfrm>
            <a:off x="58086" y="5691173"/>
            <a:ext cx="1207582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ditional Figure 3. Original blots without cuts and with the molecular weight corresponding to 15, 25, 37, 50 and 75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The antibodies used are specific for LC3B (15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and Beclin-1 (52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. The Cox IV (15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and GAPDH (36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was used as a loading control. In each lane, the mitochondrial sample of the 3 different conditions was loaded with 3 independent experiments.</a:t>
            </a:r>
          </a:p>
          <a:p>
            <a:pPr algn="just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s-MX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5591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2</Words>
  <Application>Microsoft Office PowerPoint</Application>
  <PresentationFormat>Panorámica</PresentationFormat>
  <Paragraphs>5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ebeca López</dc:creator>
  <cp:lastModifiedBy>Rebeca López</cp:lastModifiedBy>
  <cp:revision>1</cp:revision>
  <dcterms:created xsi:type="dcterms:W3CDTF">2023-11-13T17:38:34Z</dcterms:created>
  <dcterms:modified xsi:type="dcterms:W3CDTF">2023-11-13T17:39:40Z</dcterms:modified>
</cp:coreProperties>
</file>